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87" y="67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668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86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825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726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35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33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6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563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10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3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970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59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419BF-C758-4F18-BD60-0EED7B9715E2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0F8645-CC8E-4C14-8D57-40761770EB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49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39416" y="9387053"/>
            <a:ext cx="68185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lignment, SNP identification and calculation of SNP index for rust an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ate leaf spot (LLS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istance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9553" y="150091"/>
            <a:ext cx="6591472" cy="8840507"/>
            <a:chOff x="19553" y="150091"/>
            <a:chExt cx="6591472" cy="8840507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20692" y="1217762"/>
              <a:ext cx="5786022" cy="362809"/>
            </a:xfrm>
            <a:prstGeom prst="rect">
              <a:avLst/>
            </a:prstGeom>
          </p:spPr>
        </p:pic>
        <p:sp>
          <p:nvSpPr>
            <p:cNvPr id="10" name="Notched Right Arrow 9"/>
            <p:cNvSpPr/>
            <p:nvPr/>
          </p:nvSpPr>
          <p:spPr>
            <a:xfrm rot="5400000">
              <a:off x="2928721" y="1770940"/>
              <a:ext cx="539568" cy="262659"/>
            </a:xfrm>
            <a:prstGeom prst="notchedRight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6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344576" y="1620328"/>
              <a:ext cx="2014496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Variant calling and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struction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of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ference guided assembly of resistant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arent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/>
            <a:srcRect t="54440"/>
            <a:stretch/>
          </p:blipFill>
          <p:spPr>
            <a:xfrm>
              <a:off x="485223" y="2219131"/>
              <a:ext cx="5786022" cy="165297"/>
            </a:xfrm>
            <a:prstGeom prst="rect">
              <a:avLst/>
            </a:prstGeom>
          </p:spPr>
        </p:pic>
        <p:sp>
          <p:nvSpPr>
            <p:cNvPr id="13" name="Notched Right Arrow 12"/>
            <p:cNvSpPr/>
            <p:nvPr/>
          </p:nvSpPr>
          <p:spPr>
            <a:xfrm rot="5400000">
              <a:off x="2927779" y="2612381"/>
              <a:ext cx="541452" cy="262659"/>
            </a:xfrm>
            <a:prstGeom prst="notchedRight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6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329834" y="2356343"/>
              <a:ext cx="202923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igning the resistant and susceptible 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ulks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o the newly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enerated reference guided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sistant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ssembly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Notched Right Arrow 16"/>
            <p:cNvSpPr/>
            <p:nvPr/>
          </p:nvSpPr>
          <p:spPr>
            <a:xfrm rot="5400000">
              <a:off x="2919371" y="782536"/>
              <a:ext cx="531464" cy="262659"/>
            </a:xfrm>
            <a:prstGeom prst="notchedRight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6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308668" y="587703"/>
              <a:ext cx="2092388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igning the resistant parent sequence    data to the reference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- &amp; B-genome assemblies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27856" y="150091"/>
              <a:ext cx="5802901" cy="456151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82" b="1" dirty="0">
                  <a:latin typeface="Arial" panose="020B0604020202020204" pitchFamily="34" charset="0"/>
                  <a:cs typeface="Arial" panose="020B0604020202020204" pitchFamily="34" charset="0"/>
                </a:rPr>
                <a:t>WGRS data on resistant and susceptible pools of LLS and rust and resistant parent 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82937" y="7806812"/>
              <a:ext cx="6228088" cy="1183786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txBody>
            <a:bodyPr wrap="square" rtlCol="0">
              <a:spAutoFit/>
            </a:bodyPr>
            <a:lstStyle/>
            <a:p>
              <a:pPr marL="168844" indent="-168844">
                <a:buFont typeface="Arial" panose="020B0604020202020204" pitchFamily="34" charset="0"/>
                <a:buChar char="•"/>
              </a:pPr>
              <a:r>
                <a:rPr lang="en-US" sz="1182" b="1" dirty="0">
                  <a:latin typeface="Arial" panose="020B0604020202020204" pitchFamily="34" charset="0"/>
                  <a:cs typeface="Arial" panose="020B0604020202020204" pitchFamily="34" charset="0"/>
                </a:rPr>
                <a:t>Excluding the positions if reads aligned are &lt; 7 and SNP index in both the samples &lt; 0.3</a:t>
              </a:r>
              <a:endParaRPr lang="en-US" sz="1182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168844" indent="-168844">
                <a:buFont typeface="Arial" panose="020B0604020202020204" pitchFamily="34" charset="0"/>
                <a:buChar char="•"/>
              </a:pPr>
              <a:r>
                <a:rPr lang="en-US" sz="1182" b="1" dirty="0">
                  <a:latin typeface="Arial" panose="020B0604020202020204" pitchFamily="34" charset="0"/>
                  <a:cs typeface="Arial" panose="020B0604020202020204" pitchFamily="34" charset="0"/>
                </a:rPr>
                <a:t>Simulating the SNP index for the number of individuals in the bulks and calculating the delta SNP index</a:t>
              </a:r>
            </a:p>
            <a:p>
              <a:pPr marL="168844" indent="-168844">
                <a:buFont typeface="Arial" panose="020B0604020202020204" pitchFamily="34" charset="0"/>
                <a:buChar char="•"/>
              </a:pPr>
              <a:r>
                <a:rPr lang="en-US" sz="1182" b="1" dirty="0">
                  <a:latin typeface="Arial" panose="020B0604020202020204" pitchFamily="34" charset="0"/>
                  <a:cs typeface="Arial" panose="020B0604020202020204" pitchFamily="34" charset="0"/>
                </a:rPr>
                <a:t>Projections of null distribution of delta SNP index for respective depth with sliding window approach</a:t>
              </a:r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201739" y="3057210"/>
              <a:ext cx="6354510" cy="4040711"/>
              <a:chOff x="304160" y="5424335"/>
              <a:chExt cx="12904560" cy="8205745"/>
            </a:xfrm>
          </p:grpSpPr>
          <p:sp>
            <p:nvSpPr>
              <p:cNvPr id="15" name="Notched Right Arrow 14"/>
              <p:cNvSpPr/>
              <p:nvPr/>
            </p:nvSpPr>
            <p:spPr>
              <a:xfrm rot="5400000">
                <a:off x="5673200" y="7126130"/>
                <a:ext cx="1379001" cy="533400"/>
              </a:xfrm>
              <a:prstGeom prst="notchedRightArrow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86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317008" y="6695581"/>
                <a:ext cx="2570544" cy="14375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Variant calling for each of the bulk and calculation of SNP index</a:t>
                </a:r>
              </a:p>
            </p:txBody>
          </p:sp>
          <p:grpSp>
            <p:nvGrpSpPr>
              <p:cNvPr id="49" name="Group 48"/>
              <p:cNvGrpSpPr/>
              <p:nvPr/>
            </p:nvGrpSpPr>
            <p:grpSpPr>
              <a:xfrm>
                <a:off x="6686554" y="6797417"/>
                <a:ext cx="6522166" cy="1125041"/>
                <a:chOff x="5090694" y="10031626"/>
                <a:chExt cx="6522166" cy="1125041"/>
              </a:xfrm>
            </p:grpSpPr>
            <p:sp>
              <p:nvSpPr>
                <p:cNvPr id="28" name="TextBox 27"/>
                <p:cNvSpPr txBox="1"/>
                <p:nvPr/>
              </p:nvSpPr>
              <p:spPr>
                <a:xfrm>
                  <a:off x="5090694" y="10031626"/>
                  <a:ext cx="2377429" cy="11250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NP index </a:t>
                  </a:r>
                </a:p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at a given position)</a:t>
                  </a:r>
                </a:p>
              </p:txBody>
            </p:sp>
            <mc:AlternateContent xmlns:mc="http://schemas.openxmlformats.org/markup-compatibility/2006" xmlns:a14="http://schemas.microsoft.com/office/drawing/2010/main">
              <mc:Choice Requires="a14">
                <p:sp>
                  <p:nvSpPr>
                    <p:cNvPr id="29" name="TextBox 28"/>
                    <p:cNvSpPr txBox="1"/>
                    <p:nvPr/>
                  </p:nvSpPr>
                  <p:spPr>
                    <a:xfrm>
                      <a:off x="6799619" y="10408512"/>
                      <a:ext cx="224619" cy="276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0" tIns="0" rIns="0" bIns="0" rtlCol="0">
                      <a:spAutoFit/>
                    </a:bodyPr>
                    <a:lstStyle/>
                    <a:p>
                      <a:pPr/>
                      <a14:m>
                        <m:oMathPara xmlns:m="http://schemas.openxmlformats.org/officeDocument/2006/math">
                          <m:oMathParaPr>
                            <m:jc m:val="centerGroup"/>
                          </m:oMathParaPr>
                          <m:oMath xmlns:m="http://schemas.openxmlformats.org/officeDocument/2006/math">
                            <m:r>
                              <a:rPr lang="en-US" sz="886" i="1">
                                <a:latin typeface="Cambria Math" panose="02040503050406030204" pitchFamily="18" charset="0"/>
                                <a:ea typeface="Cambria Math" panose="02040503050406030204" pitchFamily="18" charset="0"/>
                              </a:rPr>
                              <m:t>=</m:t>
                            </m:r>
                          </m:oMath>
                        </m:oMathPara>
                      </a14:m>
                      <a:endParaRPr lang="en-US" sz="886" dirty="0"/>
                    </a:p>
                  </p:txBody>
                </p:sp>
              </mc:Choice>
              <mc:Fallback xmlns="">
                <p:sp>
                  <p:nvSpPr>
                    <p:cNvPr id="29" name="TextBox 28"/>
                    <p:cNvSpPr txBox="1">
                      <a:spLocks noRot="1" noChangeAspect="1" noMove="1" noResize="1" noEditPoints="1" noAdjustHandles="1" noChangeArrowheads="1" noChangeShapeType="1" noTextEdit="1"/>
                    </p:cNvSpPr>
                    <p:nvPr/>
                  </p:nvSpPr>
                  <p:spPr>
                    <a:xfrm>
                      <a:off x="6799619" y="10408512"/>
                      <a:ext cx="224619" cy="276832"/>
                    </a:xfrm>
                    <a:prstGeom prst="rect">
                      <a:avLst/>
                    </a:prstGeom>
                    <a:blipFill rotWithShape="0">
                      <a:blip r:embed="rId3"/>
                      <a:stretch>
                        <a:fillRect l="-11111" r="-5556"/>
                      </a:stretch>
                    </a:blipFill>
                  </p:spPr>
                  <p:txBody>
                    <a:bodyPr/>
                    <a:lstStyle/>
                    <a:p>
                      <a:r>
                        <a:rPr lang="en-US">
                          <a:noFill/>
                        </a:rPr>
                        <a:t> </a:t>
                      </a:r>
                    </a:p>
                  </p:txBody>
                </p:sp>
              </mc:Fallback>
            </mc:AlternateContent>
            <p:cxnSp>
              <p:nvCxnSpPr>
                <p:cNvPr id="32" name="Straight Connector 31"/>
                <p:cNvCxnSpPr/>
                <p:nvPr/>
              </p:nvCxnSpPr>
              <p:spPr>
                <a:xfrm>
                  <a:off x="7112000" y="10542636"/>
                  <a:ext cx="3441700" cy="7704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3" name="TextBox 32"/>
                <p:cNvSpPr txBox="1"/>
                <p:nvPr/>
              </p:nvSpPr>
              <p:spPr>
                <a:xfrm>
                  <a:off x="7162799" y="10088674"/>
                  <a:ext cx="4450061" cy="5000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 of alternate allele</a:t>
                  </a: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7338568" y="10542634"/>
                  <a:ext cx="3105170" cy="5000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read count</a:t>
                  </a:r>
                </a:p>
              </p:txBody>
            </p:sp>
          </p:grpSp>
          <p:grpSp>
            <p:nvGrpSpPr>
              <p:cNvPr id="40" name="Group 39"/>
              <p:cNvGrpSpPr/>
              <p:nvPr/>
            </p:nvGrpSpPr>
            <p:grpSpPr>
              <a:xfrm>
                <a:off x="892248" y="5424335"/>
                <a:ext cx="11750075" cy="1215926"/>
                <a:chOff x="892248" y="6285215"/>
                <a:chExt cx="11750075" cy="1215926"/>
              </a:xfrm>
            </p:grpSpPr>
            <p:pic>
              <p:nvPicPr>
                <p:cNvPr id="37" name="Picture 36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892248" y="6285215"/>
                  <a:ext cx="11750075" cy="1092466"/>
                </a:xfrm>
                <a:prstGeom prst="rect">
                  <a:avLst/>
                </a:prstGeom>
              </p:spPr>
            </p:pic>
            <p:sp>
              <p:nvSpPr>
                <p:cNvPr id="38" name="Rectangle 37"/>
                <p:cNvSpPr/>
                <p:nvPr/>
              </p:nvSpPr>
              <p:spPr>
                <a:xfrm>
                  <a:off x="8908146" y="6439354"/>
                  <a:ext cx="228600" cy="1061787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86"/>
                </a:p>
              </p:txBody>
            </p:sp>
            <p:sp>
              <p:nvSpPr>
                <p:cNvPr id="39" name="Rectangle 38"/>
                <p:cNvSpPr/>
                <p:nvPr/>
              </p:nvSpPr>
              <p:spPr>
                <a:xfrm>
                  <a:off x="11874500" y="6433849"/>
                  <a:ext cx="228600" cy="1061787"/>
                </a:xfrm>
                <a:prstGeom prst="rect">
                  <a:avLst/>
                </a:prstGeom>
                <a:noFill/>
                <a:ln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86"/>
                </a:p>
              </p:txBody>
            </p:sp>
          </p:grpSp>
          <p:grpSp>
            <p:nvGrpSpPr>
              <p:cNvPr id="47" name="Group 46"/>
              <p:cNvGrpSpPr/>
              <p:nvPr/>
            </p:nvGrpSpPr>
            <p:grpSpPr>
              <a:xfrm>
                <a:off x="304160" y="8257921"/>
                <a:ext cx="12799330" cy="5372159"/>
                <a:chOff x="304160" y="11455070"/>
                <a:chExt cx="12799330" cy="5372159"/>
              </a:xfrm>
            </p:grpSpPr>
            <p:pic>
              <p:nvPicPr>
                <p:cNvPr id="41" name="Picture 40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304160" y="11455840"/>
                  <a:ext cx="12393399" cy="4737426"/>
                </a:xfrm>
                <a:prstGeom prst="rect">
                  <a:avLst/>
                </a:prstGeom>
              </p:spPr>
            </p:pic>
            <p:sp>
              <p:nvSpPr>
                <p:cNvPr id="42" name="Rectangle 41"/>
                <p:cNvSpPr/>
                <p:nvPr/>
              </p:nvSpPr>
              <p:spPr>
                <a:xfrm>
                  <a:off x="4788446" y="11455070"/>
                  <a:ext cx="280705" cy="4815237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86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3" name="Rectangle 42"/>
                <p:cNvSpPr/>
                <p:nvPr/>
              </p:nvSpPr>
              <p:spPr>
                <a:xfrm>
                  <a:off x="6593046" y="11455070"/>
                  <a:ext cx="308283" cy="4815235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86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4" name="Rectangle 43"/>
                <p:cNvSpPr/>
                <p:nvPr/>
              </p:nvSpPr>
              <p:spPr>
                <a:xfrm>
                  <a:off x="8984319" y="11455838"/>
                  <a:ext cx="293885" cy="4814467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86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5" name="Rectangle 44"/>
                <p:cNvSpPr/>
                <p:nvPr/>
              </p:nvSpPr>
              <p:spPr>
                <a:xfrm>
                  <a:off x="11732894" y="11455838"/>
                  <a:ext cx="256436" cy="4801757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86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2062310" y="16270307"/>
                  <a:ext cx="11041180" cy="5569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82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NP index:        3/10=0.3      </a:t>
                  </a:r>
                  <a:r>
                    <a:rPr lang="en-US" sz="1182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4/10=0.4            7/10=0.7               10/10=1.0</a:t>
                  </a:r>
                  <a:endParaRPr lang="en-US" sz="1182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8" name="Notched Right Arrow 47"/>
            <p:cNvSpPr/>
            <p:nvPr/>
          </p:nvSpPr>
          <p:spPr>
            <a:xfrm rot="5400000">
              <a:off x="2919893" y="7241387"/>
              <a:ext cx="689083" cy="337939"/>
            </a:xfrm>
            <a:prstGeom prst="notchedRightArrow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86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60321" y="1174819"/>
              <a:ext cx="1553500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ference genome Resistant parent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9105" y="2173442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PBD 4 assembly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2295" y="3054232"/>
              <a:ext cx="1623525" cy="60016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PBD 4 assembly</a:t>
              </a:r>
            </a:p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sistant bulk</a:t>
              </a:r>
            </a:p>
            <a:p>
              <a:pPr algn="r"/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sceptible bulk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0571" y="4452538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PBD 4 assembly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0571" y="4662494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1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0571" y="4860177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2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9555" y="5081891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3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0320" y="5303605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4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0320" y="5503074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5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9554" y="5717927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6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9554" y="5932780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7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9554" y="6141470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8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9553" y="6352163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9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2093" y="6557623"/>
              <a:ext cx="162352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>
                <a:lnSpc>
                  <a:spcPts val="1320"/>
                </a:lnSpc>
              </a:pPr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equence read 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29391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00</TotalTime>
  <Words>207</Words>
  <Application>Microsoft Office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h, Vikas (ICRISAT-IN)</dc:creator>
  <cp:lastModifiedBy>Pandey</cp:lastModifiedBy>
  <cp:revision>96</cp:revision>
  <dcterms:created xsi:type="dcterms:W3CDTF">2015-04-20T11:32:42Z</dcterms:created>
  <dcterms:modified xsi:type="dcterms:W3CDTF">2016-09-26T10:44:58Z</dcterms:modified>
</cp:coreProperties>
</file>